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2" r:id="rId2"/>
  </p:sldIdLst>
  <p:sldSz cx="6858000" cy="9906000" type="A4"/>
  <p:notesSz cx="6805613" cy="99441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3144">
          <p15:clr>
            <a:srgbClr val="A4A3A4"/>
          </p15:clr>
        </p15:guide>
        <p15:guide id="2" pos="576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ijke Zonneveld" initials="" lastIdx="1" clrIdx="0"/>
  <p:cmAuthor id="1" name="Zonneveld Marijke (MAASTRO)" initials="" lastIdx="2" clrIdx="1"/>
  <p:cmAuthor id="2" name="Herwijnen, M.J.C. van (Martijn)" initials="" lastIdx="1" clrIdx="2"/>
  <p:cmAuthor id="3" name="Herwijnen, M.J.C. van (Martijn)" initials="HMv(" lastIdx="1" clrIdx="3">
    <p:extLst>
      <p:ext uri="{19B8F6BF-5375-455C-9EA6-DF929625EA0E}">
        <p15:presenceInfo xmlns:p15="http://schemas.microsoft.com/office/powerpoint/2012/main" userId="S::m.j.c.vanherwijnen@uu.nl::ba6a51fc-496c-479f-a9cc-dfc5564280f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019" autoAdjust="0"/>
    <p:restoredTop sz="88430" autoAdjust="0"/>
  </p:normalViewPr>
  <p:slideViewPr>
    <p:cSldViewPr snapToGrid="0">
      <p:cViewPr varScale="1">
        <p:scale>
          <a:sx n="46" d="100"/>
          <a:sy n="46" d="100"/>
        </p:scale>
        <p:origin x="2838" y="48"/>
      </p:cViewPr>
      <p:guideLst>
        <p:guide orient="horz" pos="3144"/>
        <p:guide pos="57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5445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44C0E47D-F600-4BC1-81E6-1C49B6E8CDE7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1243013"/>
            <a:ext cx="2322513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1038" y="4786313"/>
            <a:ext cx="5443537" cy="3914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 noProof="0"/>
              <a:t>Tekststijl van het model bewerken</a:t>
            </a:r>
          </a:p>
          <a:p>
            <a:pPr lvl="1"/>
            <a:r>
              <a:rPr lang="nl-NL" noProof="0"/>
              <a:t>Tweede niveau</a:t>
            </a:r>
          </a:p>
          <a:p>
            <a:pPr lvl="2"/>
            <a:r>
              <a:rPr lang="nl-NL" noProof="0"/>
              <a:t>Derde niveau</a:t>
            </a:r>
          </a:p>
          <a:p>
            <a:pPr lvl="3"/>
            <a:r>
              <a:rPr lang="nl-NL" noProof="0"/>
              <a:t>Vierde niveau</a:t>
            </a:r>
          </a:p>
          <a:p>
            <a:pPr lvl="4"/>
            <a:r>
              <a:rPr lang="nl-NL" noProof="0"/>
              <a:t>Vijfde niveau</a:t>
            </a:r>
            <a:endParaRPr lang="en-US" noProof="0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9445625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54450" y="9445625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5F4141AB-195E-4F16-BC03-99B88DCCD6DD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91706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4578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GB"/>
          </a:p>
        </p:txBody>
      </p:sp>
      <p:sp>
        <p:nvSpPr>
          <p:cNvPr id="29699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402B79F5-AAFF-4E4E-A808-1CE69E946B1B}" type="slidenum">
              <a:rPr lang="en-US">
                <a:cs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691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BDD676-0DF6-41DF-8ACA-692EFA5949AE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B37262-73B1-47FE-99FB-516514A2362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B29120-587C-4A7D-BF59-2F631B3C50AF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22715B-74CF-4C0F-973C-3CDFD64570F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4D3A9D-75D9-464E-9335-16BB0FB500B0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A6E3F0-15AE-45D4-8D5A-FE6B34CC3EE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9AE74B-FF80-498F-983A-FA0C71C59332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D6764-BE2A-47EE-B74D-AC00F31161F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FF1C6C-3C17-41A1-9F73-8D966F6D6464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C14DEE-8DD1-4FCD-92D0-7046C836636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3DB039-3438-4696-80A3-DA55480B6871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BB8BEF-F800-4684-B2E8-B63770CF3A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088622-3992-45AA-B097-264332CC2BC9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62DE0E-BFAC-488A-9FE6-2FAF17D82B5D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774501-20A3-4C76-BFB5-2BE1246B7DFA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42F04A-634E-4094-8D10-EE88D358C87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294E09-B267-40EF-8254-F741A3D9131E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9D0676-CBD9-4E83-B2BE-8081961E530D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6B4E09-032F-4B05-B1EF-3992E205DF8F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322830-0209-481B-AC80-5BF34273AF4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nl-NL" noProof="0"/>
              <a:t>Klik op het pictogram als u een afbeelding wilt toevoegen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15CF40-CD5B-44B5-99A9-47AB59078A03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C7A05B-B0A5-4DCF-9F14-77ED8C692D3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nl-NL"/>
              <a:t>Klik om de stijl te bewerken</a:t>
            </a:r>
            <a:endParaRPr lang="en-US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EAFDE99A-1360-4203-8156-EED701E7F10D}" type="datetimeFigureOut">
              <a:rPr lang="en-US"/>
              <a:pPr>
                <a:defRPr/>
              </a:pPr>
              <a:t>8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7EA252F-9400-4B43-817C-923FED61FC13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gif"/><Relationship Id="rId5" Type="http://schemas.openxmlformats.org/officeDocument/2006/relationships/image" Target="../media/image3.gif"/><Relationship Id="rId4" Type="http://schemas.openxmlformats.org/officeDocument/2006/relationships/image" Target="../media/image2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Tekstvak 2"/>
          <p:cNvSpPr txBox="1">
            <a:spLocks noChangeArrowheads="1"/>
          </p:cNvSpPr>
          <p:nvPr/>
        </p:nvSpPr>
        <p:spPr bwMode="auto">
          <a:xfrm>
            <a:off x="4438650" y="160338"/>
            <a:ext cx="221669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>
                <a:latin typeface="Calibri" pitchFamily="34" charset="0"/>
              </a:rPr>
              <a:t>Supplementary File </a:t>
            </a:r>
            <a:r>
              <a:rPr lang="en-US" dirty="0" smtClean="0">
                <a:latin typeface="Calibri" pitchFamily="34" charset="0"/>
              </a:rPr>
              <a:t>2 </a:t>
            </a:r>
            <a:endParaRPr lang="en-US" dirty="0">
              <a:latin typeface="Calibri" pitchFamily="34" charset="0"/>
            </a:endParaRPr>
          </a:p>
        </p:txBody>
      </p:sp>
      <p:pic>
        <p:nvPicPr>
          <p:cNvPr id="15" name="Picture 2" descr="E:\Results Wound-healing assay\Videos\Well C02 - DMEM.gif">
            <a:extLst>
              <a:ext uri="{FF2B5EF4-FFF2-40B4-BE49-F238E27FC236}">
                <a16:creationId xmlns="" xmlns:a16="http://schemas.microsoft.com/office/drawing/2014/main" id="{F515E30B-0556-48F8-9B25-82FB9DF214EA}"/>
              </a:ext>
            </a:extLst>
          </p:cNvPr>
          <p:cNvPicPr>
            <a:picLocks noChangeAspect="1" noChangeArrowheads="1" noCrop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4738" y="1715087"/>
            <a:ext cx="1403951" cy="1069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3" descr="E:\Results Wound-healing assay\Videos\Well F02 - TGF.gif">
            <a:extLst>
              <a:ext uri="{FF2B5EF4-FFF2-40B4-BE49-F238E27FC236}">
                <a16:creationId xmlns="" xmlns:a16="http://schemas.microsoft.com/office/drawing/2014/main" id="{55800B7D-55B8-4722-B021-E5DD56F33CBC}"/>
              </a:ext>
            </a:extLst>
          </p:cNvPr>
          <p:cNvPicPr>
            <a:picLocks noChangeAspect="1" noChangeArrowheads="1" noCrop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9956" y="1715087"/>
            <a:ext cx="1426356" cy="1069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7306B339-8046-4220-BDD5-1230E8846454}"/>
              </a:ext>
            </a:extLst>
          </p:cNvPr>
          <p:cNvSpPr txBox="1"/>
          <p:nvPr/>
        </p:nvSpPr>
        <p:spPr>
          <a:xfrm>
            <a:off x="566109" y="1212215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dium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D3475F1D-7F2D-46B4-A1E1-66C35535097E}"/>
              </a:ext>
            </a:extLst>
          </p:cNvPr>
          <p:cNvSpPr txBox="1"/>
          <p:nvPr/>
        </p:nvSpPr>
        <p:spPr>
          <a:xfrm>
            <a:off x="5365492" y="1213460"/>
            <a:ext cx="723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GF-a</a:t>
            </a:r>
          </a:p>
        </p:txBody>
      </p:sp>
      <p:pic>
        <p:nvPicPr>
          <p:cNvPr id="19" name="Picture 4" descr="E:\Results Wound-healing assay\Videos\Well F07 - EV-depleted donor 27.gif">
            <a:extLst>
              <a:ext uri="{FF2B5EF4-FFF2-40B4-BE49-F238E27FC236}">
                <a16:creationId xmlns="" xmlns:a16="http://schemas.microsoft.com/office/drawing/2014/main" id="{3CC00A38-4D3B-492E-AE5D-4A00733D5902}"/>
              </a:ext>
            </a:extLst>
          </p:cNvPr>
          <p:cNvPicPr>
            <a:picLocks noChangeAspect="1" noChangeArrowheads="1" noCrop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8089" y="1712788"/>
            <a:ext cx="1406969" cy="10719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5" descr="E:\Results Wound-healing assay\Videos\Well B06 - EV donor 27.gif">
            <a:extLst>
              <a:ext uri="{FF2B5EF4-FFF2-40B4-BE49-F238E27FC236}">
                <a16:creationId xmlns="" xmlns:a16="http://schemas.microsoft.com/office/drawing/2014/main" id="{070CFE91-24E7-40BD-857F-6C4F90D64D99}"/>
              </a:ext>
            </a:extLst>
          </p:cNvPr>
          <p:cNvPicPr>
            <a:picLocks noChangeAspect="1" noChangeArrowheads="1" noCrop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3634" y="1706915"/>
            <a:ext cx="1446155" cy="1077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179FBCFB-7186-4964-9360-2A83D130B93E}"/>
              </a:ext>
            </a:extLst>
          </p:cNvPr>
          <p:cNvSpPr txBox="1"/>
          <p:nvPr/>
        </p:nvSpPr>
        <p:spPr>
          <a:xfrm>
            <a:off x="3568594" y="1212215"/>
            <a:ext cx="133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-deplete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D22D266D-BD85-4669-81E7-29F22A41E3F7}"/>
              </a:ext>
            </a:extLst>
          </p:cNvPr>
          <p:cNvSpPr txBox="1"/>
          <p:nvPr/>
        </p:nvSpPr>
        <p:spPr>
          <a:xfrm>
            <a:off x="2110421" y="1213460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lk EV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682DC8FC-FFCF-48B0-85EA-53074C7DFA12}"/>
              </a:ext>
            </a:extLst>
          </p:cNvPr>
          <p:cNvSpPr txBox="1"/>
          <p:nvPr/>
        </p:nvSpPr>
        <p:spPr>
          <a:xfrm>
            <a:off x="332392" y="2916005"/>
            <a:ext cx="6316781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Legend:</a:t>
            </a:r>
          </a:p>
          <a:p>
            <a:pPr algn="just"/>
            <a:r>
              <a:rPr lang="en-US" dirty="0"/>
              <a:t>A gap was made in a confluent monolayer of Ca9-22 gingival epithelial cells and re-epithelialization was investigated in the presence of milk EVs, or milk donor-matched EV-depleted procedural </a:t>
            </a:r>
            <a:r>
              <a:rPr lang="en-US" dirty="0" smtClean="0"/>
              <a:t>control</a:t>
            </a:r>
            <a:r>
              <a:rPr lang="en-US" dirty="0"/>
              <a:t>, or TGF-α as a positive control. Cell migration was tracked by live cell imaging. Images were acquired every 20 minutes for 5 hours</a:t>
            </a:r>
            <a:r>
              <a:rPr lang="en-US" dirty="0" smtClean="0"/>
              <a:t>.</a:t>
            </a:r>
          </a:p>
          <a:p>
            <a:pPr algn="just"/>
            <a:r>
              <a:rPr lang="en-US" dirty="0" smtClean="0"/>
              <a:t>Note: view </a:t>
            </a:r>
            <a:r>
              <a:rPr lang="en-US" dirty="0"/>
              <a:t>slide in ‘slide show’ in order play </a:t>
            </a:r>
            <a:r>
              <a:rPr lang="en-US" dirty="0" smtClean="0"/>
              <a:t>video animations.</a:t>
            </a:r>
            <a:endParaRPr lang="en-US" dirty="0"/>
          </a:p>
          <a:p>
            <a:pPr algn="just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90512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83</Words>
  <Application>Microsoft Office PowerPoint</Application>
  <PresentationFormat>A4 (210 x 297 mm)</PresentationFormat>
  <Paragraphs>9</Paragraphs>
  <Slides>1</Slides>
  <Notes>1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-presentatie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Marijke Zonneveld</dc:creator>
  <cp:lastModifiedBy>Martijn</cp:lastModifiedBy>
  <cp:revision>587</cp:revision>
  <cp:lastPrinted>2019-10-08T11:05:22Z</cp:lastPrinted>
  <dcterms:created xsi:type="dcterms:W3CDTF">2016-11-09T06:53:33Z</dcterms:created>
  <dcterms:modified xsi:type="dcterms:W3CDTF">2020-08-15T21:10:04Z</dcterms:modified>
</cp:coreProperties>
</file>